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13FE44-ED53-284D-AF5D-716F9373B2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06412EF-ACC8-6E48-A508-AD97AD1943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EBA4FB5-720E-4A4A-9A1C-42693DE08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516B6B-AEAC-024F-AEDA-185206139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5D03E1-932C-F44A-93C0-213D59C86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6713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91BF2E-5325-BE40-920B-8061A0E688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0C47634-450E-F94B-87B8-53E78C6EE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7D632D1-A76E-F64D-AF7C-DEEDC64C1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8220E4-F597-F648-B155-B659A5A1E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47E2F3D-5727-B44A-A672-2CB90D54F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3324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6C430D9-CFC6-B844-BFBA-56068748C2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77031FC-BAC3-974C-868B-F51FEDB322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6C75299-E984-524A-B776-9D8040FF0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327BE35-3E10-E544-B14E-13476BE4E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88D27C-177E-584C-A8A9-D27DD0F69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4786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F4646F-1331-2B4F-A464-260C6A2FD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ABF42FB-CA98-874B-B4AB-8AE32FA609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5A63B58-42FF-9D49-851A-C521A5AB6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25E8E54-5785-F54B-AC57-9582CA6E2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DDF4075-1C53-8B4A-9ECC-359E4E8DF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9113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62D190-5524-8A49-AB7C-D27B5431A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BA3F49A-386D-6E42-9D85-1E7BCBED4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FAFABF-A1C0-A647-920B-7B2DC0B97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5E95F7-912F-114A-8351-CE6C350F7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8215BBF-B9C1-CF41-BE7F-E0CD83986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616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CE7E0F-3F98-5A45-9353-9EAEEB601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FD18509-264F-F542-A564-E8856CF936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1F481F2-2EDB-6F4C-A678-ABA2D7D20B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7A33BDF-8833-4D44-B0B4-0BDF615F9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971214-D3D0-804E-9E88-FBD05D539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93415B0-706F-AC46-88C4-20EDB6257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1873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DABEC85-6479-7042-9247-7BF565C3F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3148067-1318-D84E-A4E9-261D98FCFC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660C59C-7EFC-204E-BF4D-3A6242CCA2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409581A-50A1-6942-BE1D-70CA002535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B040FDB-B934-7B47-A17C-A36F4FBDE7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606DB46-F6E1-0641-BE7D-933ABB4E1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B784B58-B5D2-5F48-AC59-EDB93C440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FC79D8D-1895-3044-B372-4A0227195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9754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79523B5-FCE8-3B41-9D16-0415CEA48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B56BB66-7E22-FE42-9948-2185C3713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10C1ABA-E41C-054A-9C05-03B1A563D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56942EE-BC00-2546-897E-7DDACDDB0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914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9E54709-27A6-1B4C-8A75-52EE4CAFC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0A2714C-D79F-2D4F-A608-E8A14A2F5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60F6DA9-B288-5B45-B007-E4073D9CE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9351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63CFC7-0E02-AA4E-8729-0145DA5E4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4EA290-4B86-D840-B90C-3128ABD46A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9973E17-383C-414F-AAA5-B091C3C5FB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8B985B8-6B43-D74D-AEF2-31D3A6E62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42251CB-1483-BF40-B552-1E816F586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42B0C76-6DF1-2449-9BA4-209682415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3789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64193B-684C-FE43-8822-FECDBE4E2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580231-03ED-5A4B-AE16-800C3F44D0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B35A3BE-2927-154A-BDCC-00C985FF7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01CE477-7E32-6943-8F31-2081F9C2F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FD04F65-C124-7349-9301-E9CFB6849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C6998C1-E8EC-AD48-8D34-E8B53CA92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2530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57F07E2-8342-EB46-A1F2-C47BBBBD06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7BEE94-8466-2242-92F4-F4ECBF094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D791FBE-AD7C-5E4B-B90B-70765F1800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C18B7-DA3C-9547-AC73-9D97CAC99EB9}" type="datetimeFigureOut">
              <a:rPr lang="fr-FR" smtClean="0"/>
              <a:t>15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B49DD15-35DA-2A43-A1B6-C28087D3C3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FE7B634-CC16-AB48-8BA4-BA62FB6932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736941-04C6-994B-B5ED-D07624DE2F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1569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E61202D1-73E2-1D47-9E91-B59989DE6AA4}"/>
              </a:ext>
            </a:extLst>
          </p:cNvPr>
          <p:cNvGrpSpPr/>
          <p:nvPr/>
        </p:nvGrpSpPr>
        <p:grpSpPr>
          <a:xfrm>
            <a:off x="717992" y="839361"/>
            <a:ext cx="1362794" cy="1112966"/>
            <a:chOff x="2483768" y="3581400"/>
            <a:chExt cx="1362794" cy="1112966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043EC97-0203-154D-90E8-17F9D4AB5FD1}"/>
                </a:ext>
              </a:extLst>
            </p:cNvPr>
            <p:cNvSpPr/>
            <p:nvPr/>
          </p:nvSpPr>
          <p:spPr>
            <a:xfrm>
              <a:off x="2483768" y="3653408"/>
              <a:ext cx="144016" cy="144016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B8C98E3E-2943-1C42-A91D-A54FB6215C18}"/>
                </a:ext>
              </a:extLst>
            </p:cNvPr>
            <p:cNvSpPr txBox="1"/>
            <p:nvPr/>
          </p:nvSpPr>
          <p:spPr>
            <a:xfrm>
              <a:off x="2618341" y="3581400"/>
              <a:ext cx="11849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solidFill>
                    <a:srgbClr val="FF0000"/>
                  </a:solidFill>
                </a:rPr>
                <a:t>Strains</a:t>
              </a:r>
              <a:r>
                <a:rPr lang="fr-FR" sz="1000" dirty="0">
                  <a:solidFill>
                    <a:srgbClr val="FF0000"/>
                  </a:solidFill>
                </a:rPr>
                <a:t> I  </a:t>
              </a:r>
              <a:r>
                <a:rPr lang="fr-FR" sz="1000" i="1" dirty="0">
                  <a:solidFill>
                    <a:srgbClr val="FF0000"/>
                  </a:solidFill>
                </a:rPr>
                <a:t>vfmO1/P1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DA18CCE-FEA1-0C42-8227-1BCF2744C636}"/>
                </a:ext>
              </a:extLst>
            </p:cNvPr>
            <p:cNvSpPr/>
            <p:nvPr/>
          </p:nvSpPr>
          <p:spPr>
            <a:xfrm>
              <a:off x="2483768" y="3872081"/>
              <a:ext cx="144016" cy="144016"/>
            </a:xfrm>
            <a:prstGeom prst="rect">
              <a:avLst/>
            </a:prstGeom>
            <a:solidFill>
              <a:srgbClr val="99663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FFC0D87D-1125-E943-9A31-AA962D467730}"/>
                </a:ext>
              </a:extLst>
            </p:cNvPr>
            <p:cNvSpPr txBox="1"/>
            <p:nvPr/>
          </p:nvSpPr>
          <p:spPr>
            <a:xfrm>
              <a:off x="2618341" y="3800073"/>
              <a:ext cx="1188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solidFill>
                    <a:srgbClr val="996633"/>
                  </a:solidFill>
                </a:rPr>
                <a:t>Strains</a:t>
              </a:r>
              <a:r>
                <a:rPr lang="fr-FR" sz="1000" dirty="0">
                  <a:solidFill>
                    <a:srgbClr val="996633"/>
                  </a:solidFill>
                </a:rPr>
                <a:t> II </a:t>
              </a:r>
              <a:r>
                <a:rPr lang="fr-FR" sz="1000" i="1" dirty="0">
                  <a:solidFill>
                    <a:srgbClr val="996633"/>
                  </a:solidFill>
                </a:rPr>
                <a:t>vfmO1/P2</a:t>
              </a:r>
              <a:endParaRPr lang="fr-FR" sz="1000" dirty="0">
                <a:solidFill>
                  <a:srgbClr val="996633"/>
                </a:solidFill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46BB6CB-BE84-6D45-803F-EF3AE8B06831}"/>
                </a:ext>
              </a:extLst>
            </p:cNvPr>
            <p:cNvSpPr/>
            <p:nvPr/>
          </p:nvSpPr>
          <p:spPr>
            <a:xfrm>
              <a:off x="2483768" y="4088105"/>
              <a:ext cx="144016" cy="144016"/>
            </a:xfrm>
            <a:prstGeom prst="rect">
              <a:avLst/>
            </a:prstGeom>
            <a:solidFill>
              <a:srgbClr val="0070C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CC67FA7E-2B79-B642-8BEC-C81547B78CA4}"/>
                </a:ext>
              </a:extLst>
            </p:cNvPr>
            <p:cNvSpPr txBox="1"/>
            <p:nvPr/>
          </p:nvSpPr>
          <p:spPr>
            <a:xfrm>
              <a:off x="2618341" y="4016097"/>
              <a:ext cx="1220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solidFill>
                    <a:srgbClr val="0070C0"/>
                  </a:solidFill>
                </a:rPr>
                <a:t>Strains</a:t>
              </a:r>
              <a:r>
                <a:rPr lang="fr-FR" sz="1000" dirty="0">
                  <a:solidFill>
                    <a:srgbClr val="0070C0"/>
                  </a:solidFill>
                </a:rPr>
                <a:t> III </a:t>
              </a:r>
              <a:r>
                <a:rPr lang="fr-FR" sz="1000" i="1" dirty="0">
                  <a:solidFill>
                    <a:srgbClr val="0070C0"/>
                  </a:solidFill>
                </a:rPr>
                <a:t>vfmO2/P2</a:t>
              </a:r>
              <a:endParaRPr lang="fr-FR" sz="1000" dirty="0">
                <a:solidFill>
                  <a:srgbClr val="0070C0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9D71F3A-479E-E549-8AEB-D970A059A821}"/>
                </a:ext>
              </a:extLst>
            </p:cNvPr>
            <p:cNvSpPr/>
            <p:nvPr/>
          </p:nvSpPr>
          <p:spPr>
            <a:xfrm>
              <a:off x="2483768" y="4304129"/>
              <a:ext cx="144016" cy="144016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F388500C-ABD6-AA4C-8690-0BACDF0E709A}"/>
                </a:ext>
              </a:extLst>
            </p:cNvPr>
            <p:cNvSpPr txBox="1"/>
            <p:nvPr/>
          </p:nvSpPr>
          <p:spPr>
            <a:xfrm>
              <a:off x="2618341" y="4232121"/>
              <a:ext cx="12282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solidFill>
                    <a:srgbClr val="008000"/>
                  </a:solidFill>
                </a:rPr>
                <a:t>Strains</a:t>
              </a:r>
              <a:r>
                <a:rPr lang="fr-FR" sz="1000" dirty="0">
                  <a:solidFill>
                    <a:srgbClr val="008000"/>
                  </a:solidFill>
                </a:rPr>
                <a:t> IV </a:t>
              </a:r>
              <a:r>
                <a:rPr lang="fr-FR" sz="1000" i="1" dirty="0">
                  <a:solidFill>
                    <a:srgbClr val="008000"/>
                  </a:solidFill>
                </a:rPr>
                <a:t>vfmO2/P3</a:t>
              </a:r>
              <a:endParaRPr lang="fr-FR" sz="1000" dirty="0">
                <a:solidFill>
                  <a:srgbClr val="008000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1837747D-9F8A-1C4A-8E96-566BA99A1053}"/>
                </a:ext>
              </a:extLst>
            </p:cNvPr>
            <p:cNvSpPr/>
            <p:nvPr/>
          </p:nvSpPr>
          <p:spPr>
            <a:xfrm>
              <a:off x="2483768" y="4520153"/>
              <a:ext cx="144016" cy="144016"/>
            </a:xfrm>
            <a:prstGeom prst="rect">
              <a:avLst/>
            </a:prstGeom>
            <a:solidFill>
              <a:srgbClr val="FF33CC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0307C782-9200-3043-8243-BE766302CBE6}"/>
                </a:ext>
              </a:extLst>
            </p:cNvPr>
            <p:cNvSpPr txBox="1"/>
            <p:nvPr/>
          </p:nvSpPr>
          <p:spPr>
            <a:xfrm>
              <a:off x="2618341" y="4448145"/>
              <a:ext cx="11961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solidFill>
                    <a:srgbClr val="FF33CC"/>
                  </a:solidFill>
                </a:rPr>
                <a:t>Strains</a:t>
              </a:r>
              <a:r>
                <a:rPr lang="fr-FR" sz="1000" dirty="0">
                  <a:solidFill>
                    <a:srgbClr val="FF33CC"/>
                  </a:solidFill>
                </a:rPr>
                <a:t> V </a:t>
              </a:r>
              <a:r>
                <a:rPr lang="fr-FR" sz="1000" i="1" dirty="0">
                  <a:solidFill>
                    <a:srgbClr val="FF33CC"/>
                  </a:solidFill>
                </a:rPr>
                <a:t>vfmO3/P4</a:t>
              </a:r>
            </a:p>
          </p:txBody>
        </p:sp>
      </p:grpSp>
      <p:sp>
        <p:nvSpPr>
          <p:cNvPr id="27" name="ZoneTexte 26">
            <a:extLst>
              <a:ext uri="{FF2B5EF4-FFF2-40B4-BE49-F238E27FC236}">
                <a16:creationId xmlns:a16="http://schemas.microsoft.com/office/drawing/2014/main" id="{2B942BF1-1C71-7046-A00C-86FBA0FFB2C9}"/>
              </a:ext>
            </a:extLst>
          </p:cNvPr>
          <p:cNvSpPr txBox="1"/>
          <p:nvPr/>
        </p:nvSpPr>
        <p:spPr>
          <a:xfrm>
            <a:off x="755484" y="20608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5C030AF4-0543-5C4B-B7E6-6DB8486F6C1A}"/>
              </a:ext>
            </a:extLst>
          </p:cNvPr>
          <p:cNvSpPr txBox="1"/>
          <p:nvPr/>
        </p:nvSpPr>
        <p:spPr>
          <a:xfrm>
            <a:off x="6547284" y="206084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pic>
        <p:nvPicPr>
          <p:cNvPr id="29" name="Picture 2" descr="http://www.phylogeny.fr/get_result.cgi?task_id=b02e40313c3ca8c006384c4fe7c26607&amp;results_in_list=50&amp;raw=1&amp;file=phylo_tree.png">
            <a:extLst>
              <a:ext uri="{FF2B5EF4-FFF2-40B4-BE49-F238E27FC236}">
                <a16:creationId xmlns:a16="http://schemas.microsoft.com/office/drawing/2014/main" id="{03493901-877A-D14E-920C-7BED4139E1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484" y="2591072"/>
            <a:ext cx="5450013" cy="36435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2" descr="http://www.phylogeny.fr/get_result.cgi?task_id=b02e40313c3ca8c04da40bd773950aa3&amp;results_in_list=50&amp;raw=1&amp;file=phylo_tree.png">
            <a:extLst>
              <a:ext uri="{FF2B5EF4-FFF2-40B4-BE49-F238E27FC236}">
                <a16:creationId xmlns:a16="http://schemas.microsoft.com/office/drawing/2014/main" id="{31D100FB-A15E-BB41-BD53-2A1E5DFF88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47284" y="2591072"/>
            <a:ext cx="5314002" cy="334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ZoneTexte 3"/>
          <p:cNvSpPr txBox="1"/>
          <p:nvPr/>
        </p:nvSpPr>
        <p:spPr>
          <a:xfrm>
            <a:off x="6465278" y="326904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7521948" y="351503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7908540" y="4003579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86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7862895" y="3181923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75</a:t>
            </a:r>
          </a:p>
        </p:txBody>
      </p:sp>
      <p:sp>
        <p:nvSpPr>
          <p:cNvPr id="36" name="ZoneTexte 35"/>
          <p:cNvSpPr txBox="1"/>
          <p:nvPr/>
        </p:nvSpPr>
        <p:spPr>
          <a:xfrm>
            <a:off x="6574591" y="3994526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16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9169594" y="514457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1049053" y="2845117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83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565889" y="4274367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83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1201453" y="5034442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98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2331577" y="4707033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95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2883810" y="4363019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0.86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7674348" y="488054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676022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D2765C9-BD18-9D46-A40A-7F730994A13D}"/>
              </a:ext>
            </a:extLst>
          </p:cNvPr>
          <p:cNvSpPr/>
          <p:nvPr/>
        </p:nvSpPr>
        <p:spPr>
          <a:xfrm>
            <a:off x="729575" y="389801"/>
            <a:ext cx="1084634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Figure S2. </a:t>
            </a:r>
            <a:r>
              <a:rPr lang="en-GB" sz="1600" b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Phylogenetic trees based on the genes </a:t>
            </a:r>
            <a:r>
              <a:rPr lang="en-GB" sz="1600" b="1" i="1" dirty="0" err="1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gapA</a:t>
            </a:r>
            <a:r>
              <a:rPr lang="en-GB" sz="1600" b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 and </a:t>
            </a:r>
            <a:r>
              <a:rPr lang="en-GB" sz="1600" b="1" i="1" dirty="0" err="1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vfmI</a:t>
            </a:r>
            <a:r>
              <a:rPr lang="en-GB" sz="1600" b="1" i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 </a:t>
            </a:r>
            <a:r>
              <a:rPr lang="en-GB" sz="1600" b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of a selection of </a:t>
            </a:r>
            <a:r>
              <a:rPr lang="en-GB" sz="1600" b="1" i="1" dirty="0" err="1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Dickeya</a:t>
            </a:r>
            <a:r>
              <a:rPr lang="en-GB" sz="1600" b="1" dirty="0">
                <a:latin typeface="Times New Roman" panose="02020603050405020304" pitchFamily="18" charset="0"/>
                <a:ea typeface="Times" pitchFamily="2" charset="0"/>
                <a:cs typeface="Times New Roman" panose="02020603050405020304" pitchFamily="18" charset="0"/>
              </a:rPr>
              <a:t> strains (the same selection of strains as on figure 4)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or three strains belonging to different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f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tic groups were retained for each species, except for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aceiphil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se two strains belong to group V. The color code used for each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f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tic group (I to V) is indicated 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top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ner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simplify the figure, the names of the species are indicated as follow: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c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ysanthemi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ree strains)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d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dant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wo strains)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f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ngzhongda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hree strains)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r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yza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wo strains)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o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aceiphil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wo strains)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so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an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wo strains); Dun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icol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wo strains)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z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a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(two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)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cleotide sequences of the genes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p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993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fm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320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ave been obtained from genome sequences available in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xcept for the strain NCPPB 2929 sequenced in the present study 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fm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numbers given in Table S1). Nucleotide sequences have been aligned with MUSCLE (Edgar, 2004), the phylogenetic tree was reconstructed using the maximum likelihood method implemented in th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M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ram (Guindon and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scue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03) and graphical representation of the phylogenetic tree was performed with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eDy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evene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06). Numbers at nodes correspond to bootstrap values (500 replicates of the original alignment).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ostrap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are given only for the main nodes that separate the species. The scale bar represents the average number of substitutions per site. </a:t>
            </a:r>
          </a:p>
          <a:p>
            <a:pPr algn="just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00163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7</TotalTime>
  <Words>347</Words>
  <Application>Microsoft Macintosh PowerPoint</Application>
  <PresentationFormat>Grand écran</PresentationFormat>
  <Paragraphs>2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nique ROYER-EL MHAMDI</dc:creator>
  <cp:lastModifiedBy>Monique ROYER-EL MHAMDI</cp:lastModifiedBy>
  <cp:revision>12</cp:revision>
  <dcterms:created xsi:type="dcterms:W3CDTF">2021-10-18T13:23:45Z</dcterms:created>
  <dcterms:modified xsi:type="dcterms:W3CDTF">2021-11-15T13:55:16Z</dcterms:modified>
</cp:coreProperties>
</file>